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8" r:id="rId3"/>
    <p:sldId id="266" r:id="rId4"/>
    <p:sldId id="267" r:id="rId5"/>
    <p:sldId id="269" r:id="rId6"/>
    <p:sldId id="270" r:id="rId7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297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100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967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720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442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203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088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727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01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381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555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701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892A3-35AE-4F58-8517-5999F7594D09}" type="datetimeFigureOut">
              <a:rPr lang="en-US" smtClean="0"/>
              <a:t>11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5AB94-D50F-41A3-A831-6939CE038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34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openxmlformats.org/officeDocument/2006/relationships/image" Target="../media/image10.png"/><Relationship Id="rId26" Type="http://schemas.openxmlformats.org/officeDocument/2006/relationships/image" Target="../media/image15.emf"/><Relationship Id="rId3" Type="http://schemas.openxmlformats.org/officeDocument/2006/relationships/oleObject" Target="../embeddings/oleObject1.bin"/><Relationship Id="rId21" Type="http://schemas.microsoft.com/office/2007/relationships/hdphoto" Target="../media/hdphoto7.wdp"/><Relationship Id="rId7" Type="http://schemas.microsoft.com/office/2007/relationships/hdphoto" Target="../media/hdphoto1.wdp"/><Relationship Id="rId12" Type="http://schemas.microsoft.com/office/2007/relationships/hdphoto" Target="../media/hdphoto3.wdp"/><Relationship Id="rId17" Type="http://schemas.microsoft.com/office/2007/relationships/hdphoto" Target="../media/hdphoto5.wdp"/><Relationship Id="rId25" Type="http://schemas.openxmlformats.org/officeDocument/2006/relationships/image" Target="../media/image14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24" Type="http://schemas.openxmlformats.org/officeDocument/2006/relationships/image" Target="../media/image13.tiff"/><Relationship Id="rId5" Type="http://schemas.openxmlformats.org/officeDocument/2006/relationships/image" Target="../media/image2.jpeg"/><Relationship Id="rId15" Type="http://schemas.openxmlformats.org/officeDocument/2006/relationships/image" Target="../media/image8.tiff"/><Relationship Id="rId23" Type="http://schemas.microsoft.com/office/2007/relationships/hdphoto" Target="../media/hdphoto8.wdp"/><Relationship Id="rId10" Type="http://schemas.openxmlformats.org/officeDocument/2006/relationships/image" Target="../media/image5.jpeg"/><Relationship Id="rId19" Type="http://schemas.microsoft.com/office/2007/relationships/hdphoto" Target="../media/hdphoto6.wdp"/><Relationship Id="rId4" Type="http://schemas.openxmlformats.org/officeDocument/2006/relationships/image" Target="../media/image1.emf"/><Relationship Id="rId9" Type="http://schemas.microsoft.com/office/2007/relationships/hdphoto" Target="../media/hdphoto2.wdp"/><Relationship Id="rId14" Type="http://schemas.microsoft.com/office/2007/relationships/hdphoto" Target="../media/hdphoto4.wdp"/><Relationship Id="rId22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em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0.wdp"/><Relationship Id="rId5" Type="http://schemas.openxmlformats.org/officeDocument/2006/relationships/image" Target="../media/image24.png"/><Relationship Id="rId4" Type="http://schemas.microsoft.com/office/2007/relationships/hdphoto" Target="../media/hdphoto9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13" Type="http://schemas.openxmlformats.org/officeDocument/2006/relationships/image" Target="../media/image35.png"/><Relationship Id="rId18" Type="http://schemas.microsoft.com/office/2007/relationships/hdphoto" Target="../media/hdphoto18.wdp"/><Relationship Id="rId26" Type="http://schemas.microsoft.com/office/2007/relationships/hdphoto" Target="../media/hdphoto22.wdp"/><Relationship Id="rId3" Type="http://schemas.openxmlformats.org/officeDocument/2006/relationships/image" Target="../media/image30.png"/><Relationship Id="rId21" Type="http://schemas.openxmlformats.org/officeDocument/2006/relationships/image" Target="../media/image39.png"/><Relationship Id="rId7" Type="http://schemas.openxmlformats.org/officeDocument/2006/relationships/image" Target="../media/image32.png"/><Relationship Id="rId12" Type="http://schemas.microsoft.com/office/2007/relationships/hdphoto" Target="../media/hdphoto15.wdp"/><Relationship Id="rId17" Type="http://schemas.openxmlformats.org/officeDocument/2006/relationships/image" Target="../media/image37.png"/><Relationship Id="rId25" Type="http://schemas.openxmlformats.org/officeDocument/2006/relationships/image" Target="../media/image41.png"/><Relationship Id="rId2" Type="http://schemas.openxmlformats.org/officeDocument/2006/relationships/image" Target="../media/image29.png"/><Relationship Id="rId16" Type="http://schemas.microsoft.com/office/2007/relationships/hdphoto" Target="../media/hdphoto17.wdp"/><Relationship Id="rId20" Type="http://schemas.microsoft.com/office/2007/relationships/hdphoto" Target="../media/hdphoto19.wdp"/><Relationship Id="rId1" Type="http://schemas.openxmlformats.org/officeDocument/2006/relationships/slideLayout" Target="../slideLayouts/slideLayout7.xml"/><Relationship Id="rId6" Type="http://schemas.microsoft.com/office/2007/relationships/hdphoto" Target="../media/hdphoto12.wdp"/><Relationship Id="rId11" Type="http://schemas.openxmlformats.org/officeDocument/2006/relationships/image" Target="../media/image34.png"/><Relationship Id="rId24" Type="http://schemas.microsoft.com/office/2007/relationships/hdphoto" Target="../media/hdphoto21.wdp"/><Relationship Id="rId5" Type="http://schemas.openxmlformats.org/officeDocument/2006/relationships/image" Target="../media/image31.png"/><Relationship Id="rId15" Type="http://schemas.openxmlformats.org/officeDocument/2006/relationships/image" Target="../media/image36.png"/><Relationship Id="rId23" Type="http://schemas.openxmlformats.org/officeDocument/2006/relationships/image" Target="../media/image40.png"/><Relationship Id="rId10" Type="http://schemas.microsoft.com/office/2007/relationships/hdphoto" Target="../media/hdphoto14.wdp"/><Relationship Id="rId19" Type="http://schemas.openxmlformats.org/officeDocument/2006/relationships/image" Target="../media/image38.png"/><Relationship Id="rId4" Type="http://schemas.microsoft.com/office/2007/relationships/hdphoto" Target="../media/hdphoto11.wdp"/><Relationship Id="rId9" Type="http://schemas.openxmlformats.org/officeDocument/2006/relationships/image" Target="../media/image33.png"/><Relationship Id="rId14" Type="http://schemas.microsoft.com/office/2007/relationships/hdphoto" Target="../media/hdphoto16.wdp"/><Relationship Id="rId22" Type="http://schemas.microsoft.com/office/2007/relationships/hdphoto" Target="../media/hdphoto20.wdp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 Box 94"/>
          <p:cNvSpPr txBox="1">
            <a:spLocks noChangeArrowheads="1"/>
          </p:cNvSpPr>
          <p:nvPr/>
        </p:nvSpPr>
        <p:spPr bwMode="auto">
          <a:xfrm>
            <a:off x="4763748" y="-57232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 Box 33"/>
          <p:cNvSpPr txBox="1">
            <a:spLocks noChangeArrowheads="1"/>
          </p:cNvSpPr>
          <p:nvPr/>
        </p:nvSpPr>
        <p:spPr bwMode="auto">
          <a:xfrm>
            <a:off x="8429" y="686005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33"/>
          <p:cNvSpPr txBox="1">
            <a:spLocks noChangeArrowheads="1"/>
          </p:cNvSpPr>
          <p:nvPr/>
        </p:nvSpPr>
        <p:spPr bwMode="auto">
          <a:xfrm>
            <a:off x="854704" y="7950312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33"/>
          <p:cNvSpPr txBox="1">
            <a:spLocks noChangeArrowheads="1"/>
          </p:cNvSpPr>
          <p:nvPr/>
        </p:nvSpPr>
        <p:spPr bwMode="auto">
          <a:xfrm>
            <a:off x="28366" y="4310739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 Box 33"/>
          <p:cNvSpPr txBox="1">
            <a:spLocks noChangeArrowheads="1"/>
          </p:cNvSpPr>
          <p:nvPr/>
        </p:nvSpPr>
        <p:spPr bwMode="auto">
          <a:xfrm>
            <a:off x="4638136" y="4344529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4535593" y="4661865"/>
            <a:ext cx="2220947" cy="2592627"/>
            <a:chOff x="4608537" y="3891601"/>
            <a:chExt cx="2220947" cy="2592627"/>
          </a:xfrm>
        </p:grpSpPr>
        <p:sp>
          <p:nvSpPr>
            <p:cNvPr id="52" name="TextBox 51"/>
            <p:cNvSpPr txBox="1"/>
            <p:nvPr/>
          </p:nvSpPr>
          <p:spPr>
            <a:xfrm rot="16200000">
              <a:off x="3920034" y="4980701"/>
              <a:ext cx="180789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verage number of 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melipodia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er cel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45589" y="6041309"/>
              <a:ext cx="1151670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</a:t>
              </a:r>
            </a:p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4" name="Object 5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63568430"/>
                </p:ext>
              </p:extLst>
            </p:nvPr>
          </p:nvGraphicFramePr>
          <p:xfrm>
            <a:off x="4963331" y="3891601"/>
            <a:ext cx="1665287" cy="2239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6" name="Prism 6" r:id="rId3" imgW="1664907" imgH="2239798" progId="Prism6.Document">
                    <p:embed/>
                  </p:oleObj>
                </mc:Choice>
                <mc:Fallback>
                  <p:oleObj name="Prism 6" r:id="rId3" imgW="1664907" imgH="2239798" progId="Prism6.Document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963331" y="3891601"/>
                          <a:ext cx="1665287" cy="2239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5" name="Text Box 28"/>
            <p:cNvSpPr txBox="1">
              <a:spLocks noChangeArrowheads="1"/>
            </p:cNvSpPr>
            <p:nvPr/>
          </p:nvSpPr>
          <p:spPr bwMode="auto">
            <a:xfrm>
              <a:off x="5740102" y="6053341"/>
              <a:ext cx="1089382" cy="430887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82769" y="4414422"/>
            <a:ext cx="4934827" cy="3041249"/>
            <a:chOff x="-12735" y="3764478"/>
            <a:chExt cx="4934827" cy="3041249"/>
          </a:xfrm>
        </p:grpSpPr>
        <p:grpSp>
          <p:nvGrpSpPr>
            <p:cNvPr id="30" name="Group 29"/>
            <p:cNvGrpSpPr/>
            <p:nvPr/>
          </p:nvGrpSpPr>
          <p:grpSpPr>
            <a:xfrm>
              <a:off x="-12735" y="3764478"/>
              <a:ext cx="4934827" cy="3041249"/>
              <a:chOff x="6462472" y="855088"/>
              <a:chExt cx="4934827" cy="3041249"/>
            </a:xfrm>
          </p:grpSpPr>
          <p:pic>
            <p:nvPicPr>
              <p:cNvPr id="31" name="Picture 30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856" t="26503" r="32316" b="13498"/>
              <a:stretch/>
            </p:blipFill>
            <p:spPr>
              <a:xfrm>
                <a:off x="9577521" y="2444289"/>
                <a:ext cx="1280162" cy="1280160"/>
              </a:xfrm>
              <a:prstGeom prst="rect">
                <a:avLst/>
              </a:prstGeom>
            </p:spPr>
          </p:pic>
          <p:pic>
            <p:nvPicPr>
              <p:cNvPr id="32" name="Picture 31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0"/>
                        </a14:imgEffect>
                        <a14:imgEffect>
                          <a14:brightnessContrast brigh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152" t="24909" r="35989" b="15090"/>
              <a:stretch/>
            </p:blipFill>
            <p:spPr>
              <a:xfrm>
                <a:off x="6906790" y="2444289"/>
                <a:ext cx="1281103" cy="1280160"/>
              </a:xfrm>
              <a:prstGeom prst="rect">
                <a:avLst/>
              </a:prstGeom>
            </p:spPr>
          </p:pic>
          <p:pic>
            <p:nvPicPr>
              <p:cNvPr id="33" name="Picture 32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0"/>
                        </a14:imgEffect>
                        <a14:imgEffect>
                          <a14:brightnessContrast brigh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524" t="24485" r="30648" b="15515"/>
              <a:stretch/>
            </p:blipFill>
            <p:spPr>
              <a:xfrm>
                <a:off x="8236966" y="2444289"/>
                <a:ext cx="1280162" cy="1280160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045" t="18661" r="33017" b="21340"/>
              <a:stretch/>
            </p:blipFill>
            <p:spPr>
              <a:xfrm>
                <a:off x="9577522" y="1106820"/>
                <a:ext cx="1283222" cy="1280160"/>
              </a:xfrm>
              <a:prstGeom prst="rect">
                <a:avLst/>
              </a:prstGeom>
            </p:spPr>
          </p:pic>
          <p:pic>
            <p:nvPicPr>
              <p:cNvPr id="35" name="Picture 34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aturation sat="0"/>
                        </a14:imgEffect>
                        <a14:imgEffect>
                          <a14:brightnessContrast brigh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007" t="14572" r="28954" b="24972"/>
              <a:stretch/>
            </p:blipFill>
            <p:spPr>
              <a:xfrm>
                <a:off x="6906789" y="1106820"/>
                <a:ext cx="1276404" cy="1280160"/>
              </a:xfrm>
              <a:prstGeom prst="rect">
                <a:avLst/>
              </a:prstGeom>
            </p:spPr>
          </p:pic>
          <p:pic>
            <p:nvPicPr>
              <p:cNvPr id="36" name="Picture 35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aturation sat="0"/>
                        </a14:imgEffect>
                        <a14:imgEffect>
                          <a14:brightnessContrast brigh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653" t="16358" r="29521" b="23642"/>
              <a:stretch/>
            </p:blipFill>
            <p:spPr>
              <a:xfrm>
                <a:off x="8236967" y="1106820"/>
                <a:ext cx="1280159" cy="1280160"/>
              </a:xfrm>
              <a:prstGeom prst="rect">
                <a:avLst/>
              </a:prstGeom>
            </p:spPr>
          </p:pic>
          <p:sp>
            <p:nvSpPr>
              <p:cNvPr id="37" name="TextBox 36"/>
              <p:cNvSpPr txBox="1"/>
              <p:nvPr/>
            </p:nvSpPr>
            <p:spPr>
              <a:xfrm rot="16200000">
                <a:off x="5828450" y="2800650"/>
                <a:ext cx="172970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8/HPAF-shSEMA5A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7285239" y="855088"/>
                <a:ext cx="1527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8568276" y="855088"/>
                <a:ext cx="1527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9870251" y="855088"/>
                <a:ext cx="1527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RGE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6200000">
                <a:off x="5929781" y="1595602"/>
                <a:ext cx="152704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8/HPAF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84" t="88893" r="3551" b="7171"/>
            <a:stretch/>
          </p:blipFill>
          <p:spPr>
            <a:xfrm>
              <a:off x="4105180" y="6500533"/>
              <a:ext cx="164592" cy="44961"/>
            </a:xfrm>
            <a:prstGeom prst="rect">
              <a:avLst/>
            </a:prstGeom>
          </p:spPr>
        </p:pic>
        <p:pic>
          <p:nvPicPr>
            <p:cNvPr id="59" name="Picture 58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84" t="88893" r="3551" b="7171"/>
            <a:stretch/>
          </p:blipFill>
          <p:spPr>
            <a:xfrm>
              <a:off x="4105180" y="5152929"/>
              <a:ext cx="164592" cy="44961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84" t="88893" r="3551" b="7171"/>
            <a:stretch/>
          </p:blipFill>
          <p:spPr>
            <a:xfrm>
              <a:off x="2770256" y="6500533"/>
              <a:ext cx="164592" cy="44961"/>
            </a:xfrm>
            <a:prstGeom prst="rect">
              <a:avLst/>
            </a:prstGeom>
          </p:spPr>
        </p:pic>
        <p:pic>
          <p:nvPicPr>
            <p:cNvPr id="61" name="Picture 60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84" t="88893" r="3551" b="7171"/>
            <a:stretch/>
          </p:blipFill>
          <p:spPr>
            <a:xfrm>
              <a:off x="2762572" y="5152929"/>
              <a:ext cx="164592" cy="44961"/>
            </a:xfrm>
            <a:prstGeom prst="rect">
              <a:avLst/>
            </a:prstGeom>
          </p:spPr>
        </p:pic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84" t="88893" r="3551" b="7171"/>
            <a:stretch/>
          </p:blipFill>
          <p:spPr>
            <a:xfrm>
              <a:off x="1440516" y="6500533"/>
              <a:ext cx="164592" cy="44961"/>
            </a:xfrm>
            <a:prstGeom prst="rect">
              <a:avLst/>
            </a:prstGeom>
          </p:spPr>
        </p:pic>
        <p:pic>
          <p:nvPicPr>
            <p:cNvPr id="63" name="Picture 62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84" t="88893" r="3551" b="7171"/>
            <a:stretch/>
          </p:blipFill>
          <p:spPr>
            <a:xfrm>
              <a:off x="1440516" y="5152929"/>
              <a:ext cx="164592" cy="44961"/>
            </a:xfrm>
            <a:prstGeom prst="rect">
              <a:avLst/>
            </a:prstGeom>
            <a:ln>
              <a:noFill/>
            </a:ln>
          </p:spPr>
        </p:pic>
      </p:grpSp>
      <p:cxnSp>
        <p:nvCxnSpPr>
          <p:cNvPr id="89" name="Straight Connector 88"/>
          <p:cNvCxnSpPr/>
          <p:nvPr/>
        </p:nvCxnSpPr>
        <p:spPr>
          <a:xfrm>
            <a:off x="1868129" y="3602177"/>
            <a:ext cx="16459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grpSp>
        <p:nvGrpSpPr>
          <p:cNvPr id="42" name="Group 41"/>
          <p:cNvGrpSpPr/>
          <p:nvPr/>
        </p:nvGrpSpPr>
        <p:grpSpPr>
          <a:xfrm>
            <a:off x="139323" y="657199"/>
            <a:ext cx="4255146" cy="3753495"/>
            <a:chOff x="-145334" y="209196"/>
            <a:chExt cx="4255146" cy="3753495"/>
          </a:xfrm>
        </p:grpSpPr>
        <p:grpSp>
          <p:nvGrpSpPr>
            <p:cNvPr id="27" name="Group 26"/>
            <p:cNvGrpSpPr/>
            <p:nvPr/>
          </p:nvGrpSpPr>
          <p:grpSpPr>
            <a:xfrm>
              <a:off x="-145334" y="209196"/>
              <a:ext cx="4255146" cy="3753495"/>
              <a:chOff x="1306954" y="707020"/>
              <a:chExt cx="4255146" cy="3753495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453"/>
              <a:stretch/>
            </p:blipFill>
            <p:spPr>
              <a:xfrm>
                <a:off x="1698446" y="1199789"/>
                <a:ext cx="1692496" cy="13716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saturation sat="0"/>
                        </a14:imgEffect>
                        <a14:imgEffect>
                          <a14:brightnessContrast bright="25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62"/>
              <a:stretch/>
            </p:blipFill>
            <p:spPr>
              <a:xfrm>
                <a:off x="1698446" y="2664699"/>
                <a:ext cx="1694174" cy="13716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453"/>
              <a:stretch/>
            </p:blipFill>
            <p:spPr>
              <a:xfrm>
                <a:off x="3447025" y="1199789"/>
                <a:ext cx="1692496" cy="13716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saturation sat="0"/>
                        </a14:imgEffect>
                        <a14:imgEffect>
                          <a14:brightnessContrast bright="24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70"/>
              <a:stretch/>
            </p:blipFill>
            <p:spPr>
              <a:xfrm>
                <a:off x="3460008" y="2664699"/>
                <a:ext cx="1691640" cy="138312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3035031" y="905104"/>
                <a:ext cx="25270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8/HPAF-shSEMA5A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306954" y="905104"/>
                <a:ext cx="25270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8/HPAF-Control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" name="Straight Connector 7"/>
              <p:cNvCxnSpPr/>
              <p:nvPr/>
            </p:nvCxnSpPr>
            <p:spPr>
              <a:xfrm flipH="1">
                <a:off x="2385256" y="1199789"/>
                <a:ext cx="4929" cy="2835533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 flipH="1">
                <a:off x="2811455" y="1199788"/>
                <a:ext cx="4929" cy="2835533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4057171" y="1200278"/>
                <a:ext cx="4750" cy="2847542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4423441" y="1200765"/>
                <a:ext cx="4750" cy="2847542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 rot="16200000">
                <a:off x="318195" y="1832055"/>
                <a:ext cx="25270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Hour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318194" y="3058481"/>
                <a:ext cx="25270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 Hour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1700302" y="2012368"/>
              <a:ext cx="1885162" cy="1437409"/>
              <a:chOff x="1700302" y="2012368"/>
              <a:chExt cx="1885162" cy="1437409"/>
            </a:xfrm>
          </p:grpSpPr>
          <p:cxnSp>
            <p:nvCxnSpPr>
              <p:cNvPr id="85" name="Straight Connector 84"/>
              <p:cNvCxnSpPr/>
              <p:nvPr/>
            </p:nvCxnSpPr>
            <p:spPr>
              <a:xfrm>
                <a:off x="1715729" y="3449777"/>
                <a:ext cx="91440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1700302" y="2012368"/>
                <a:ext cx="91440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>
                <a:off x="3494024" y="2012368"/>
                <a:ext cx="91440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>
                <a:off x="3494024" y="3449777"/>
                <a:ext cx="91440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8" name="Group 17"/>
          <p:cNvGrpSpPr/>
          <p:nvPr/>
        </p:nvGrpSpPr>
        <p:grpSpPr>
          <a:xfrm>
            <a:off x="1545059" y="8104201"/>
            <a:ext cx="3205978" cy="1329290"/>
            <a:chOff x="3743316" y="1355213"/>
            <a:chExt cx="3205978" cy="1329290"/>
          </a:xfrm>
        </p:grpSpPr>
        <p:grpSp>
          <p:nvGrpSpPr>
            <p:cNvPr id="25" name="Group 24"/>
            <p:cNvGrpSpPr/>
            <p:nvPr/>
          </p:nvGrpSpPr>
          <p:grpSpPr>
            <a:xfrm>
              <a:off x="3743316" y="1355213"/>
              <a:ext cx="3205978" cy="1132652"/>
              <a:chOff x="1515748" y="4890549"/>
              <a:chExt cx="3205978" cy="1132652"/>
            </a:xfrm>
          </p:grpSpPr>
          <p:sp>
            <p:nvSpPr>
              <p:cNvPr id="17" name="TextBox 16"/>
              <p:cNvSpPr txBox="1"/>
              <p:nvPr/>
            </p:nvSpPr>
            <p:spPr>
              <a:xfrm rot="16200000">
                <a:off x="1318258" y="5548712"/>
                <a:ext cx="6719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ascin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795593" y="4890549"/>
                <a:ext cx="21463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3M-4-Control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122088" y="4890549"/>
                <a:ext cx="159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3M-4-shSEMA5A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3508" y="1678663"/>
              <a:ext cx="1346278" cy="100584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27042" y="1671735"/>
              <a:ext cx="1346278" cy="100584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  <p:grpSp>
        <p:nvGrpSpPr>
          <p:cNvPr id="19" name="Group 18"/>
          <p:cNvGrpSpPr/>
          <p:nvPr/>
        </p:nvGrpSpPr>
        <p:grpSpPr>
          <a:xfrm>
            <a:off x="4502138" y="1301812"/>
            <a:ext cx="2121732" cy="2665584"/>
            <a:chOff x="4158568" y="821972"/>
            <a:chExt cx="2121732" cy="2665584"/>
          </a:xfrm>
        </p:grpSpPr>
        <p:grpSp>
          <p:nvGrpSpPr>
            <p:cNvPr id="64" name="Group 63"/>
            <p:cNvGrpSpPr/>
            <p:nvPr/>
          </p:nvGrpSpPr>
          <p:grpSpPr>
            <a:xfrm>
              <a:off x="4158568" y="821972"/>
              <a:ext cx="1968976" cy="2638512"/>
              <a:chOff x="2088309" y="4716661"/>
              <a:chExt cx="1968976" cy="2638512"/>
            </a:xfrm>
          </p:grpSpPr>
          <p:pic>
            <p:nvPicPr>
              <p:cNvPr id="65" name="Picture 64"/>
              <p:cNvPicPr>
                <a:picLocks noChangeAspect="1"/>
              </p:cNvPicPr>
              <p:nvPr/>
            </p:nvPicPr>
            <p:blipFill rotWithShape="1">
              <a:blip r:embed="rId26"/>
              <a:srcRect l="22653"/>
              <a:stretch/>
            </p:blipFill>
            <p:spPr>
              <a:xfrm>
                <a:off x="2383507" y="4716661"/>
                <a:ext cx="1673778" cy="2318667"/>
              </a:xfrm>
              <a:prstGeom prst="rect">
                <a:avLst/>
              </a:prstGeom>
            </p:spPr>
          </p:pic>
          <p:grpSp>
            <p:nvGrpSpPr>
              <p:cNvPr id="66" name="Group 65"/>
              <p:cNvGrpSpPr/>
              <p:nvPr/>
            </p:nvGrpSpPr>
            <p:grpSpPr>
              <a:xfrm>
                <a:off x="2088309" y="5046570"/>
                <a:ext cx="1254499" cy="2308603"/>
                <a:chOff x="2088309" y="5046570"/>
                <a:chExt cx="1254499" cy="2308603"/>
              </a:xfrm>
            </p:grpSpPr>
            <p:sp>
              <p:nvSpPr>
                <p:cNvPr id="67" name="TextBox 66"/>
                <p:cNvSpPr txBox="1"/>
                <p:nvPr/>
              </p:nvSpPr>
              <p:spPr>
                <a:xfrm>
                  <a:off x="2478506" y="6924286"/>
                  <a:ext cx="864302" cy="43088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3M-4-</a:t>
                  </a:r>
                </a:p>
                <a:p>
                  <a:pPr algn="ctr"/>
                  <a:r>
                    <a:rPr lang="en-US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 rot="16200000">
                  <a:off x="1280256" y="5854623"/>
                  <a:ext cx="1877716" cy="2616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umber of Migrated cells</a:t>
                  </a:r>
                  <a:endParaRPr 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69" name="Text Box 28"/>
            <p:cNvSpPr txBox="1">
              <a:spLocks noChangeArrowheads="1"/>
            </p:cNvSpPr>
            <p:nvPr/>
          </p:nvSpPr>
          <p:spPr bwMode="auto">
            <a:xfrm>
              <a:off x="5260312" y="3056669"/>
              <a:ext cx="1019988" cy="430887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M-4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Text Box 33"/>
          <p:cNvSpPr txBox="1">
            <a:spLocks noChangeArrowheads="1"/>
          </p:cNvSpPr>
          <p:nvPr/>
        </p:nvSpPr>
        <p:spPr bwMode="auto">
          <a:xfrm>
            <a:off x="4638136" y="718027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73470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33"/>
          <p:cNvSpPr txBox="1">
            <a:spLocks noChangeArrowheads="1"/>
          </p:cNvSpPr>
          <p:nvPr/>
        </p:nvSpPr>
        <p:spPr bwMode="auto">
          <a:xfrm>
            <a:off x="151150" y="4021612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5659" y="1012173"/>
            <a:ext cx="2462997" cy="3084843"/>
          </a:xfrm>
          <a:prstGeom prst="rect">
            <a:avLst/>
          </a:prstGeom>
        </p:spPr>
      </p:pic>
      <p:sp>
        <p:nvSpPr>
          <p:cNvPr id="8" name="Text Box 33"/>
          <p:cNvSpPr txBox="1">
            <a:spLocks noChangeArrowheads="1"/>
          </p:cNvSpPr>
          <p:nvPr/>
        </p:nvSpPr>
        <p:spPr bwMode="auto">
          <a:xfrm>
            <a:off x="151150" y="809365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33"/>
          <p:cNvSpPr txBox="1">
            <a:spLocks noChangeArrowheads="1"/>
          </p:cNvSpPr>
          <p:nvPr/>
        </p:nvSpPr>
        <p:spPr bwMode="auto">
          <a:xfrm>
            <a:off x="3506842" y="809365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8930" y="1048752"/>
            <a:ext cx="2627604" cy="3048264"/>
          </a:xfrm>
          <a:prstGeom prst="rect">
            <a:avLst/>
          </a:prstGeom>
        </p:spPr>
      </p:pic>
      <p:sp>
        <p:nvSpPr>
          <p:cNvPr id="13" name="Text Box 33"/>
          <p:cNvSpPr txBox="1">
            <a:spLocks noChangeArrowheads="1"/>
          </p:cNvSpPr>
          <p:nvPr/>
        </p:nvSpPr>
        <p:spPr bwMode="auto">
          <a:xfrm>
            <a:off x="151150" y="7392797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94"/>
          <p:cNvSpPr txBox="1">
            <a:spLocks noChangeArrowheads="1"/>
          </p:cNvSpPr>
          <p:nvPr/>
        </p:nvSpPr>
        <p:spPr bwMode="auto">
          <a:xfrm>
            <a:off x="4719079" y="-28558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112311" y="4301539"/>
            <a:ext cx="7007667" cy="3225628"/>
            <a:chOff x="354685" y="4301539"/>
            <a:chExt cx="7007667" cy="3225628"/>
          </a:xfrm>
        </p:grpSpPr>
        <p:grpSp>
          <p:nvGrpSpPr>
            <p:cNvPr id="25" name="Group 24"/>
            <p:cNvGrpSpPr/>
            <p:nvPr/>
          </p:nvGrpSpPr>
          <p:grpSpPr>
            <a:xfrm>
              <a:off x="516896" y="4301539"/>
              <a:ext cx="6268915" cy="2979838"/>
              <a:chOff x="516896" y="4301539"/>
              <a:chExt cx="6268915" cy="2979838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53" t="1" r="34399" b="41263"/>
              <a:stretch/>
            </p:blipFill>
            <p:spPr>
              <a:xfrm>
                <a:off x="642796" y="4301539"/>
                <a:ext cx="3187599" cy="2941233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516896" y="4402432"/>
                <a:ext cx="227443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8/HPAF-Control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89" t="-1133" r="38179" b="40761"/>
              <a:stretch/>
            </p:blipFill>
            <p:spPr>
              <a:xfrm>
                <a:off x="3739081" y="4306446"/>
                <a:ext cx="3046730" cy="2963487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3607471" y="4402432"/>
                <a:ext cx="2083460" cy="277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8/HPAF-shSEMA5A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724526" y="7065933"/>
                <a:ext cx="79809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8.31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641762" y="7065933"/>
                <a:ext cx="79809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4.20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824662" y="7065933"/>
                <a:ext cx="79809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5.59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741898" y="7065933"/>
                <a:ext cx="79809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8.90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 rot="16200000">
              <a:off x="84061" y="5649689"/>
              <a:ext cx="8182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3215910" y="5649689"/>
              <a:ext cx="8182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421574" y="7250168"/>
              <a:ext cx="14039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2A FL2A-Area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649201" y="7250168"/>
              <a:ext cx="14039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2A FL2A-Area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127553" y="5136306"/>
              <a:ext cx="209990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1/G0: 49.25%</a:t>
              </a:r>
            </a:p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S: 36.07%</a:t>
              </a:r>
            </a:p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G2/M: 14.68%</a:t>
              </a:r>
            </a:p>
            <a:p>
              <a:endParaRPr lang="en-US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262446" y="5136306"/>
              <a:ext cx="209990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1/G0: 59.01%</a:t>
              </a:r>
            </a:p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S: 29.12%</a:t>
              </a:r>
            </a:p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G2/M: 11.87%</a:t>
              </a:r>
            </a:p>
            <a:p>
              <a:endParaRPr lang="en-US" dirty="0"/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2187716" y="7423085"/>
            <a:ext cx="3652950" cy="2443647"/>
            <a:chOff x="2187716" y="7423085"/>
            <a:chExt cx="3652950" cy="2443647"/>
          </a:xfrm>
        </p:grpSpPr>
        <p:grpSp>
          <p:nvGrpSpPr>
            <p:cNvPr id="31" name="Group 30"/>
            <p:cNvGrpSpPr/>
            <p:nvPr/>
          </p:nvGrpSpPr>
          <p:grpSpPr>
            <a:xfrm>
              <a:off x="2187716" y="7466296"/>
              <a:ext cx="3652950" cy="2400436"/>
              <a:chOff x="2187716" y="7400194"/>
              <a:chExt cx="3652950" cy="2400436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938549" y="7928116"/>
                <a:ext cx="1902117" cy="554784"/>
              </a:xfrm>
              <a:prstGeom prst="rect">
                <a:avLst/>
              </a:prstGeom>
            </p:spPr>
          </p:pic>
          <p:grpSp>
            <p:nvGrpSpPr>
              <p:cNvPr id="30" name="Group 29"/>
              <p:cNvGrpSpPr/>
              <p:nvPr/>
            </p:nvGrpSpPr>
            <p:grpSpPr>
              <a:xfrm>
                <a:off x="2187716" y="7400194"/>
                <a:ext cx="2013928" cy="2400436"/>
                <a:chOff x="2187716" y="7400194"/>
                <a:chExt cx="2013928" cy="2400436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 rot="16200000">
                  <a:off x="1201263" y="8386647"/>
                  <a:ext cx="224990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Cycle Distribution (%)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613959" y="9523631"/>
                  <a:ext cx="7124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1/G0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3251223" y="9523631"/>
                  <a:ext cx="7124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3489148" y="9523631"/>
                  <a:ext cx="7124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2/M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453602" y="7423085"/>
              <a:ext cx="1689694" cy="226933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884388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oup 30"/>
          <p:cNvGraphicFramePr>
            <a:graphicFrameLocks/>
          </p:cNvGraphicFramePr>
          <p:nvPr>
            <p:extLst/>
          </p:nvPr>
        </p:nvGraphicFramePr>
        <p:xfrm>
          <a:off x="1519568" y="629236"/>
          <a:ext cx="2688351" cy="1428305"/>
        </p:xfrm>
        <a:graphic>
          <a:graphicData uri="http://schemas.openxmlformats.org/drawingml/2006/table">
            <a:tbl>
              <a:tblPr/>
              <a:tblGrid>
                <a:gridCol w="13441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441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508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Tumor incidence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98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ontrol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6/6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390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shSEMA5A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6/6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" name="Text Box 33"/>
          <p:cNvSpPr txBox="1">
            <a:spLocks noChangeArrowheads="1"/>
          </p:cNvSpPr>
          <p:nvPr/>
        </p:nvSpPr>
        <p:spPr bwMode="auto">
          <a:xfrm>
            <a:off x="174205" y="636420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 Box 35"/>
          <p:cNvSpPr txBox="1">
            <a:spLocks noChangeArrowheads="1"/>
          </p:cNvSpPr>
          <p:nvPr/>
        </p:nvSpPr>
        <p:spPr bwMode="auto">
          <a:xfrm>
            <a:off x="174205" y="2312013"/>
            <a:ext cx="6103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B            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34"/>
          <p:cNvSpPr txBox="1">
            <a:spLocks noChangeArrowheads="1"/>
          </p:cNvSpPr>
          <p:nvPr/>
        </p:nvSpPr>
        <p:spPr bwMode="auto">
          <a:xfrm>
            <a:off x="174204" y="6066319"/>
            <a:ext cx="58270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C  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38"/>
          <p:cNvSpPr txBox="1">
            <a:spLocks noChangeArrowheads="1"/>
          </p:cNvSpPr>
          <p:nvPr/>
        </p:nvSpPr>
        <p:spPr bwMode="auto">
          <a:xfrm>
            <a:off x="1564502" y="5742801"/>
            <a:ext cx="1600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3M-4-Contro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38"/>
          <p:cNvSpPr txBox="1">
            <a:spLocks noChangeArrowheads="1"/>
          </p:cNvSpPr>
          <p:nvPr/>
        </p:nvSpPr>
        <p:spPr bwMode="auto">
          <a:xfrm>
            <a:off x="3799572" y="5742801"/>
            <a:ext cx="20574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3M-4-shSEMA5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-22294" y="6156536"/>
            <a:ext cx="1890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 &amp; 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94"/>
          <p:cNvSpPr txBox="1">
            <a:spLocks noChangeArrowheads="1"/>
          </p:cNvSpPr>
          <p:nvPr/>
        </p:nvSpPr>
        <p:spPr bwMode="auto">
          <a:xfrm>
            <a:off x="4405622" y="0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1104576" y="2260376"/>
            <a:ext cx="4149631" cy="3168175"/>
            <a:chOff x="1104576" y="2260376"/>
            <a:chExt cx="4149631" cy="3168175"/>
          </a:xfrm>
        </p:grpSpPr>
        <p:sp>
          <p:nvSpPr>
            <p:cNvPr id="7" name="TextBox 6"/>
            <p:cNvSpPr txBox="1"/>
            <p:nvPr/>
          </p:nvSpPr>
          <p:spPr>
            <a:xfrm rot="16200000">
              <a:off x="232682" y="3509480"/>
              <a:ext cx="20207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umor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olume 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mm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045735" y="5151552"/>
              <a:ext cx="152400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2"/>
            <a:srcRect l="4427" b="7053"/>
            <a:stretch/>
          </p:blipFill>
          <p:spPr>
            <a:xfrm>
              <a:off x="1396964" y="2260376"/>
              <a:ext cx="3857243" cy="2923926"/>
            </a:xfrm>
            <a:prstGeom prst="rect">
              <a:avLst/>
            </a:prstGeom>
          </p:spPr>
        </p:pic>
      </p:grpSp>
      <p:cxnSp>
        <p:nvCxnSpPr>
          <p:cNvPr id="21" name="Straight Connector 20"/>
          <p:cNvCxnSpPr/>
          <p:nvPr/>
        </p:nvCxnSpPr>
        <p:spPr>
          <a:xfrm flipV="1">
            <a:off x="3781283" y="7777950"/>
            <a:ext cx="18289" cy="24713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3320" y="6013048"/>
            <a:ext cx="2438400" cy="18288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884" y="6013048"/>
            <a:ext cx="2438400" cy="18288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31" name="Straight Connector 30"/>
          <p:cNvCxnSpPr/>
          <p:nvPr/>
        </p:nvCxnSpPr>
        <p:spPr>
          <a:xfrm>
            <a:off x="3362344" y="7747478"/>
            <a:ext cx="3657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5856972" y="7747910"/>
            <a:ext cx="3657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22670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oup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5256735"/>
              </p:ext>
            </p:extLst>
          </p:nvPr>
        </p:nvGraphicFramePr>
        <p:xfrm>
          <a:off x="105100" y="6528554"/>
          <a:ext cx="6705600" cy="1166195"/>
        </p:xfrm>
        <a:graphic>
          <a:graphicData uri="http://schemas.openxmlformats.org/drawingml/2006/table">
            <a:tbl>
              <a:tblPr/>
              <a:tblGrid>
                <a:gridCol w="20779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750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1953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121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2096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5659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1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itchFamily="-107" charset="-128"/>
                          <a:cs typeface="Times New Roman" pitchFamily="-107" charset="0"/>
                        </a:rPr>
                        <a:t>Incidence (%)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pitchFamily="-107" charset="-128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Primary tumor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Mets to liver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Mets to spleen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Peritoneum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831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</a:rPr>
                        <a:t>T3M-4-Control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75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75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75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</a:rPr>
                        <a:t>T3M-4-shSEMA5A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" name="Text Box 94"/>
          <p:cNvSpPr txBox="1">
            <a:spLocks noChangeArrowheads="1"/>
          </p:cNvSpPr>
          <p:nvPr/>
        </p:nvSpPr>
        <p:spPr bwMode="auto">
          <a:xfrm>
            <a:off x="4687389" y="90079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4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94"/>
          <p:cNvSpPr txBox="1">
            <a:spLocks noChangeArrowheads="1"/>
          </p:cNvSpPr>
          <p:nvPr/>
        </p:nvSpPr>
        <p:spPr bwMode="auto">
          <a:xfrm>
            <a:off x="152400" y="584011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A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Group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4561555"/>
              </p:ext>
            </p:extLst>
          </p:nvPr>
        </p:nvGraphicFramePr>
        <p:xfrm>
          <a:off x="104272" y="8181931"/>
          <a:ext cx="6705600" cy="1341120"/>
        </p:xfrm>
        <a:graphic>
          <a:graphicData uri="http://schemas.openxmlformats.org/drawingml/2006/table">
            <a:tbl>
              <a:tblPr/>
              <a:tblGrid>
                <a:gridCol w="20012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22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849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84980">
                  <a:extLst>
                    <a:ext uri="{9D8B030D-6E8A-4147-A177-3AD203B41FA5}">
                      <a16:colId xmlns:a16="http://schemas.microsoft.com/office/drawing/2014/main" val="2987490491"/>
                    </a:ext>
                  </a:extLst>
                </a:gridCol>
                <a:gridCol w="105215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598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5659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1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itchFamily="-107" charset="-128"/>
                          <a:cs typeface="Times New Roman" pitchFamily="-107" charset="0"/>
                        </a:rPr>
                        <a:t>Incidence (%)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pitchFamily="-107" charset="-128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Primary tumor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Mets to liver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1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pitchFamily="-107" charset="-128"/>
                          <a:cs typeface="Times New Roman" pitchFamily="-107" charset="0"/>
                        </a:rPr>
                        <a:t>Mets to Lymph nod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Mets to spleen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Peritoneum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831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</a:rPr>
                        <a:t>CD18/HPAF-Control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8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6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6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6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</a:rPr>
                        <a:t>CD18/HPAF-shSEMA5A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10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pitchFamily="-107" charset="-128"/>
                          <a:cs typeface="Times New Roman" pitchFamily="-107" charset="0"/>
                        </a:rPr>
                        <a:t>4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pSp>
        <p:nvGrpSpPr>
          <p:cNvPr id="41" name="Group 40"/>
          <p:cNvGrpSpPr/>
          <p:nvPr/>
        </p:nvGrpSpPr>
        <p:grpSpPr>
          <a:xfrm>
            <a:off x="1057965" y="769288"/>
            <a:ext cx="2168450" cy="2640521"/>
            <a:chOff x="413569" y="4403557"/>
            <a:chExt cx="2168450" cy="264052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26329" t="30348" r="49621"/>
            <a:stretch/>
          </p:blipFill>
          <p:spPr>
            <a:xfrm>
              <a:off x="750087" y="4403557"/>
              <a:ext cx="1528011" cy="2288495"/>
            </a:xfrm>
            <a:prstGeom prst="rect">
              <a:avLst/>
            </a:prstGeom>
          </p:spPr>
        </p:pic>
        <p:sp>
          <p:nvSpPr>
            <p:cNvPr id="31" name="Text Box 28"/>
            <p:cNvSpPr txBox="1">
              <a:spLocks noChangeArrowheads="1"/>
            </p:cNvSpPr>
            <p:nvPr/>
          </p:nvSpPr>
          <p:spPr bwMode="auto">
            <a:xfrm>
              <a:off x="1492637" y="6613191"/>
              <a:ext cx="1089382" cy="430887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87365" y="6613191"/>
              <a:ext cx="102702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</a:t>
              </a:r>
            </a:p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-359573" y="5431203"/>
              <a:ext cx="1807894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ice Weight (g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3972121" y="769288"/>
            <a:ext cx="2216578" cy="2558794"/>
            <a:chOff x="3833965" y="4427620"/>
            <a:chExt cx="2216578" cy="2558794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3"/>
            <a:srcRect l="25928" t="32506" r="49493"/>
            <a:stretch/>
          </p:blipFill>
          <p:spPr>
            <a:xfrm>
              <a:off x="4090736" y="4427620"/>
              <a:ext cx="1564105" cy="2217591"/>
            </a:xfrm>
            <a:prstGeom prst="rect">
              <a:avLst/>
            </a:prstGeom>
          </p:spPr>
        </p:pic>
        <p:sp>
          <p:nvSpPr>
            <p:cNvPr id="37" name="Text Box 28"/>
            <p:cNvSpPr txBox="1">
              <a:spLocks noChangeArrowheads="1"/>
            </p:cNvSpPr>
            <p:nvPr/>
          </p:nvSpPr>
          <p:spPr bwMode="auto">
            <a:xfrm>
              <a:off x="4961161" y="6555527"/>
              <a:ext cx="1089382" cy="430887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055889" y="6555527"/>
              <a:ext cx="102702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</a:t>
              </a:r>
            </a:p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3060823" y="5373539"/>
              <a:ext cx="1807894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Tumor  Weight (g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1066491" y="3452331"/>
            <a:ext cx="2322646" cy="2678306"/>
            <a:chOff x="928335" y="7110663"/>
            <a:chExt cx="2322646" cy="2678306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4"/>
            <a:srcRect l="26700" t="29615" r="49477"/>
            <a:stretch/>
          </p:blipFill>
          <p:spPr>
            <a:xfrm>
              <a:off x="1371599" y="7110663"/>
              <a:ext cx="1515979" cy="2312558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 rot="16200000">
              <a:off x="239832" y="8208881"/>
              <a:ext cx="180789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umber of  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acromets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er Live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 Box 28"/>
            <p:cNvSpPr txBox="1">
              <a:spLocks noChangeArrowheads="1"/>
            </p:cNvSpPr>
            <p:nvPr/>
          </p:nvSpPr>
          <p:spPr bwMode="auto">
            <a:xfrm>
              <a:off x="2161599" y="9358082"/>
              <a:ext cx="1089382" cy="430887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256327" y="9358082"/>
              <a:ext cx="102702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</a:t>
              </a:r>
            </a:p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3887482" y="3476392"/>
            <a:ext cx="2427213" cy="2680730"/>
            <a:chOff x="3749326" y="7194884"/>
            <a:chExt cx="2427213" cy="2680730"/>
          </a:xfrm>
        </p:grpSpPr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5"/>
            <a:srcRect l="25448" t="28968" r="47515"/>
            <a:stretch/>
          </p:blipFill>
          <p:spPr>
            <a:xfrm>
              <a:off x="4162926" y="7194884"/>
              <a:ext cx="1720516" cy="2333808"/>
            </a:xfrm>
            <a:prstGeom prst="rect">
              <a:avLst/>
            </a:prstGeom>
          </p:spPr>
        </p:pic>
        <p:sp>
          <p:nvSpPr>
            <p:cNvPr id="50" name="TextBox 49"/>
            <p:cNvSpPr txBox="1"/>
            <p:nvPr/>
          </p:nvSpPr>
          <p:spPr>
            <a:xfrm rot="16200000">
              <a:off x="3060823" y="8146344"/>
              <a:ext cx="180789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umber of  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cromets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er Live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 Box 28"/>
            <p:cNvSpPr txBox="1">
              <a:spLocks noChangeArrowheads="1"/>
            </p:cNvSpPr>
            <p:nvPr/>
          </p:nvSpPr>
          <p:spPr bwMode="auto">
            <a:xfrm>
              <a:off x="5087157" y="9444727"/>
              <a:ext cx="1089382" cy="430887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181885" y="9444727"/>
              <a:ext cx="102702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</a:t>
              </a:r>
            </a:p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Text Box 94"/>
          <p:cNvSpPr txBox="1">
            <a:spLocks noChangeArrowheads="1"/>
          </p:cNvSpPr>
          <p:nvPr/>
        </p:nvSpPr>
        <p:spPr bwMode="auto">
          <a:xfrm>
            <a:off x="3612803" y="584011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B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 Box 94"/>
          <p:cNvSpPr txBox="1">
            <a:spLocks noChangeArrowheads="1"/>
          </p:cNvSpPr>
          <p:nvPr/>
        </p:nvSpPr>
        <p:spPr bwMode="auto">
          <a:xfrm>
            <a:off x="152400" y="3390734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C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94"/>
          <p:cNvSpPr txBox="1">
            <a:spLocks noChangeArrowheads="1"/>
          </p:cNvSpPr>
          <p:nvPr/>
        </p:nvSpPr>
        <p:spPr bwMode="auto">
          <a:xfrm>
            <a:off x="3612803" y="3390734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D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94"/>
          <p:cNvSpPr txBox="1">
            <a:spLocks noChangeArrowheads="1"/>
          </p:cNvSpPr>
          <p:nvPr/>
        </p:nvSpPr>
        <p:spPr bwMode="auto">
          <a:xfrm>
            <a:off x="152400" y="6066450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E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 Box 94"/>
          <p:cNvSpPr txBox="1">
            <a:spLocks noChangeArrowheads="1"/>
          </p:cNvSpPr>
          <p:nvPr/>
        </p:nvSpPr>
        <p:spPr bwMode="auto">
          <a:xfrm>
            <a:off x="152400" y="7802323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F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77903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94"/>
          <p:cNvSpPr txBox="1">
            <a:spLocks noChangeArrowheads="1"/>
          </p:cNvSpPr>
          <p:nvPr/>
        </p:nvSpPr>
        <p:spPr bwMode="auto">
          <a:xfrm>
            <a:off x="4685487" y="35808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4405535" y="2793781"/>
            <a:ext cx="163053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4693093" y="2661256"/>
            <a:ext cx="8229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28" name="Text Box 94"/>
          <p:cNvSpPr txBox="1">
            <a:spLocks noChangeArrowheads="1"/>
          </p:cNvSpPr>
          <p:nvPr/>
        </p:nvSpPr>
        <p:spPr bwMode="auto">
          <a:xfrm>
            <a:off x="575624" y="3786625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B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2126630" y="3967399"/>
            <a:ext cx="2542834" cy="2683125"/>
            <a:chOff x="2126630" y="3967399"/>
            <a:chExt cx="2542834" cy="2683125"/>
          </a:xfrm>
        </p:grpSpPr>
        <p:sp>
          <p:nvSpPr>
            <p:cNvPr id="30" name="TextBox 29"/>
            <p:cNvSpPr txBox="1"/>
            <p:nvPr/>
          </p:nvSpPr>
          <p:spPr>
            <a:xfrm>
              <a:off x="3142416" y="6219637"/>
              <a:ext cx="152704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226052" y="6219637"/>
              <a:ext cx="152704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2"/>
            <a:srcRect r="63065"/>
            <a:stretch/>
          </p:blipFill>
          <p:spPr>
            <a:xfrm>
              <a:off x="2507819" y="3967399"/>
              <a:ext cx="2127892" cy="2328874"/>
            </a:xfrm>
            <a:prstGeom prst="rect">
              <a:avLst/>
            </a:prstGeom>
          </p:spPr>
        </p:pic>
        <p:sp>
          <p:nvSpPr>
            <p:cNvPr id="48" name="TextBox 47"/>
            <p:cNvSpPr txBox="1"/>
            <p:nvPr/>
          </p:nvSpPr>
          <p:spPr>
            <a:xfrm rot="16200000">
              <a:off x="1273234" y="4888993"/>
              <a:ext cx="2137680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ized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NAIL Expression(</a:t>
              </a:r>
              <a:r>
                <a:rPr lang="en-US" sz="1100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DD</a:t>
              </a:r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q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Text Box 94"/>
          <p:cNvSpPr txBox="1">
            <a:spLocks noChangeArrowheads="1"/>
          </p:cNvSpPr>
          <p:nvPr/>
        </p:nvSpPr>
        <p:spPr bwMode="auto">
          <a:xfrm>
            <a:off x="575624" y="631840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A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 Box 94"/>
          <p:cNvSpPr txBox="1">
            <a:spLocks noChangeArrowheads="1"/>
          </p:cNvSpPr>
          <p:nvPr/>
        </p:nvSpPr>
        <p:spPr bwMode="auto">
          <a:xfrm>
            <a:off x="575624" y="6960261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C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526627" y="7061687"/>
            <a:ext cx="4184241" cy="2455276"/>
            <a:chOff x="543914" y="3661855"/>
            <a:chExt cx="4184241" cy="2455276"/>
          </a:xfrm>
        </p:grpSpPr>
        <p:sp>
          <p:nvSpPr>
            <p:cNvPr id="9" name="TextBox 8"/>
            <p:cNvSpPr txBox="1"/>
            <p:nvPr/>
          </p:nvSpPr>
          <p:spPr>
            <a:xfrm>
              <a:off x="2139893" y="3672063"/>
              <a:ext cx="1527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atenin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84" t="31372" r="17734"/>
            <a:stretch/>
          </p:blipFill>
          <p:spPr>
            <a:xfrm>
              <a:off x="3058406" y="4890128"/>
              <a:ext cx="1012623" cy="9144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  <a14:imgEffect>
                        <a14:brightnessContrast bright="5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00" t="31158" r="12346" b="-1"/>
            <a:stretch/>
          </p:blipFill>
          <p:spPr>
            <a:xfrm>
              <a:off x="943857" y="4882338"/>
              <a:ext cx="1014301" cy="9144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  <a14:imgEffect>
                        <a14:brightnessContrast bright="3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56" t="31585" r="11680"/>
            <a:stretch/>
          </p:blipFill>
          <p:spPr>
            <a:xfrm>
              <a:off x="2001722" y="4890128"/>
              <a:ext cx="1019037" cy="9144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 rot="16200000">
              <a:off x="-4166" y="5138163"/>
              <a:ext cx="152704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-shSEMA5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193094" y="3661855"/>
              <a:ext cx="1527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201107" y="3661855"/>
              <a:ext cx="1527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995" t="177" r="483" b="32550"/>
            <a:stretch/>
          </p:blipFill>
          <p:spPr>
            <a:xfrm>
              <a:off x="3058406" y="3921978"/>
              <a:ext cx="1010093" cy="9144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  <a14:imgEffect>
                        <a14:brightnessContrast bright="55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06" b="31124"/>
            <a:stretch/>
          </p:blipFill>
          <p:spPr>
            <a:xfrm>
              <a:off x="943857" y="3921978"/>
              <a:ext cx="1012761" cy="9144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  <a14:imgEffect>
                        <a14:brightnessContrast bright="3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769" t="727" r="1021" b="31383"/>
            <a:stretch/>
          </p:blipFill>
          <p:spPr>
            <a:xfrm>
              <a:off x="2001722" y="3921967"/>
              <a:ext cx="1013339" cy="91440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 rot="16200000">
              <a:off x="-4166" y="4212886"/>
              <a:ext cx="152704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8/HPAF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3850860" y="5736451"/>
              <a:ext cx="8229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3850860" y="4786795"/>
              <a:ext cx="8229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2773697" y="5736451"/>
              <a:ext cx="8229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2773697" y="4786795"/>
              <a:ext cx="8229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1756727" y="5736451"/>
              <a:ext cx="8229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1756727" y="4786795"/>
              <a:ext cx="8229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</p:grpSp>
      <p:sp>
        <p:nvSpPr>
          <p:cNvPr id="59" name="Rectangle 58"/>
          <p:cNvSpPr/>
          <p:nvPr/>
        </p:nvSpPr>
        <p:spPr>
          <a:xfrm>
            <a:off x="3861344" y="2793781"/>
            <a:ext cx="237790" cy="235128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7" name="Group 76"/>
          <p:cNvGrpSpPr/>
          <p:nvPr/>
        </p:nvGrpSpPr>
        <p:grpSpPr>
          <a:xfrm>
            <a:off x="1185395" y="993367"/>
            <a:ext cx="5227242" cy="2462203"/>
            <a:chOff x="1185395" y="993367"/>
            <a:chExt cx="5227242" cy="2462203"/>
          </a:xfrm>
        </p:grpSpPr>
        <p:grpSp>
          <p:nvGrpSpPr>
            <p:cNvPr id="65" name="Group 64"/>
            <p:cNvGrpSpPr/>
            <p:nvPr/>
          </p:nvGrpSpPr>
          <p:grpSpPr>
            <a:xfrm>
              <a:off x="1185395" y="993367"/>
              <a:ext cx="5227242" cy="2462203"/>
              <a:chOff x="1185395" y="993367"/>
              <a:chExt cx="5227242" cy="2462203"/>
            </a:xfrm>
          </p:grpSpPr>
          <p:grpSp>
            <p:nvGrpSpPr>
              <p:cNvPr id="58" name="Group 57"/>
              <p:cNvGrpSpPr/>
              <p:nvPr/>
            </p:nvGrpSpPr>
            <p:grpSpPr>
              <a:xfrm>
                <a:off x="1185395" y="993367"/>
                <a:ext cx="5227242" cy="2462203"/>
                <a:chOff x="1185395" y="993367"/>
                <a:chExt cx="5227242" cy="2462203"/>
              </a:xfrm>
            </p:grpSpPr>
            <p:grpSp>
              <p:nvGrpSpPr>
                <p:cNvPr id="56" name="Group 55"/>
                <p:cNvGrpSpPr/>
                <p:nvPr/>
              </p:nvGrpSpPr>
              <p:grpSpPr>
                <a:xfrm>
                  <a:off x="1185395" y="993367"/>
                  <a:ext cx="5227242" cy="2462203"/>
                  <a:chOff x="1185395" y="993367"/>
                  <a:chExt cx="5227242" cy="2462203"/>
                </a:xfrm>
              </p:grpSpPr>
              <p:grpSp>
                <p:nvGrpSpPr>
                  <p:cNvPr id="54" name="Group 53"/>
                  <p:cNvGrpSpPr/>
                  <p:nvPr/>
                </p:nvGrpSpPr>
                <p:grpSpPr>
                  <a:xfrm>
                    <a:off x="1185395" y="993367"/>
                    <a:ext cx="4566939" cy="2462203"/>
                    <a:chOff x="1185395" y="993367"/>
                    <a:chExt cx="4566939" cy="2462203"/>
                  </a:xfrm>
                </p:grpSpPr>
                <p:grpSp>
                  <p:nvGrpSpPr>
                    <p:cNvPr id="27" name="Group 26"/>
                    <p:cNvGrpSpPr/>
                    <p:nvPr/>
                  </p:nvGrpSpPr>
                  <p:grpSpPr>
                    <a:xfrm>
                      <a:off x="1185395" y="993367"/>
                      <a:ext cx="4184241" cy="2462203"/>
                      <a:chOff x="543914" y="555729"/>
                      <a:chExt cx="4184241" cy="2462203"/>
                    </a:xfrm>
                  </p:grpSpPr>
                  <p:pic>
                    <p:nvPicPr>
                      <p:cNvPr id="15" name="Picture 14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5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6">
                                <a14:imgEffect>
                                  <a14:brightnessContrast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8570" t="7583" r="24580" b="23666"/>
                      <a:stretch/>
                    </p:blipFill>
                    <p:spPr>
                      <a:xfrm>
                        <a:off x="3058406" y="870660"/>
                        <a:ext cx="1012059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6" name="Picture 15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7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8">
                                <a14:imgEffect>
                                  <a14:saturation sat="0"/>
                                </a14:imgEffect>
                                <a14:imgEffect>
                                  <a14:brightnessContrast bright="55000"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8401" t="10498" r="24941" b="20750"/>
                      <a:stretch/>
                    </p:blipFill>
                    <p:spPr>
                      <a:xfrm>
                        <a:off x="943857" y="870660"/>
                        <a:ext cx="1008612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7" name="Picture 16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9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0">
                                <a14:imgEffect>
                                  <a14:saturation sat="0"/>
                                </a14:imgEffect>
                                <a14:imgEffect>
                                  <a14:brightnessContrast bright="30000"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4678" t="10500" r="28665" b="20750"/>
                      <a:stretch/>
                    </p:blipFill>
                    <p:spPr>
                      <a:xfrm>
                        <a:off x="2001722" y="870660"/>
                        <a:ext cx="1008610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8" name="Picture 17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1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2">
                                <a14:imgEffect>
                                  <a14:saturation sat="0"/>
                                </a14:imgEffect>
                                <a14:imgEffect>
                                  <a14:brightnessContrast bright="30000"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3191" t="31279" r="3"/>
                      <a:stretch/>
                    </p:blipFill>
                    <p:spPr>
                      <a:xfrm>
                        <a:off x="2001722" y="1831613"/>
                        <a:ext cx="1011668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9" name="Picture 18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3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4">
                                <a14:imgEffect>
                                  <a14:brightnessContrast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3378" t="31370" r="-1" b="1"/>
                      <a:stretch/>
                    </p:blipFill>
                    <p:spPr>
                      <a:xfrm>
                        <a:off x="3058406" y="1831613"/>
                        <a:ext cx="1009792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0" name="Picture 19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5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6">
                                <a14:imgEffect>
                                  <a14:saturation sat="0"/>
                                </a14:imgEffect>
                                <a14:imgEffect>
                                  <a14:brightnessContrast bright="55000"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3136" t="31322" r="-1"/>
                      <a:stretch/>
                    </p:blipFill>
                    <p:spPr>
                      <a:xfrm>
                        <a:off x="943857" y="1831613"/>
                        <a:ext cx="1013364" cy="9144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1" name="TextBox 20"/>
                      <p:cNvSpPr txBox="1"/>
                      <p:nvPr/>
                    </p:nvSpPr>
                    <p:spPr>
                      <a:xfrm rot="16200000">
                        <a:off x="-4166" y="2038964"/>
                        <a:ext cx="1527048" cy="43088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18/HPAF-shSEMA5A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2" name="TextBox 21"/>
                      <p:cNvSpPr txBox="1"/>
                      <p:nvPr/>
                    </p:nvSpPr>
                    <p:spPr>
                      <a:xfrm>
                        <a:off x="1156256" y="618928"/>
                        <a:ext cx="1527048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API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3" name="TextBox 22"/>
                      <p:cNvSpPr txBox="1"/>
                      <p:nvPr/>
                    </p:nvSpPr>
                    <p:spPr>
                      <a:xfrm>
                        <a:off x="2229151" y="618928"/>
                        <a:ext cx="1527048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E-cad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4" name="TextBox 23"/>
                      <p:cNvSpPr txBox="1"/>
                      <p:nvPr/>
                    </p:nvSpPr>
                    <p:spPr>
                      <a:xfrm>
                        <a:off x="3201107" y="618928"/>
                        <a:ext cx="1527048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ERGE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5" name="TextBox 24"/>
                      <p:cNvSpPr txBox="1"/>
                      <p:nvPr/>
                    </p:nvSpPr>
                    <p:spPr>
                      <a:xfrm rot="16200000">
                        <a:off x="-4166" y="1103809"/>
                        <a:ext cx="1527048" cy="43088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18/HPAF</a:t>
                        </a:r>
                      </a:p>
                      <a:p>
                        <a:pPr algn="ctr"/>
                        <a:r>
                          <a:rPr lang="en-US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37" name="Straight Connector 36"/>
                      <p:cNvCxnSpPr/>
                      <p:nvPr/>
                    </p:nvCxnSpPr>
                    <p:spPr>
                      <a:xfrm>
                        <a:off x="3850860" y="1711600"/>
                        <a:ext cx="82296" cy="0"/>
                      </a:xfrm>
                      <a:prstGeom prst="line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8" name="Straight Connector 37"/>
                      <p:cNvCxnSpPr/>
                      <p:nvPr/>
                    </p:nvCxnSpPr>
                    <p:spPr>
                      <a:xfrm>
                        <a:off x="2773697" y="2661256"/>
                        <a:ext cx="82296" cy="0"/>
                      </a:xfrm>
                      <a:prstGeom prst="line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9" name="Straight Connector 38"/>
                      <p:cNvCxnSpPr/>
                      <p:nvPr/>
                    </p:nvCxnSpPr>
                    <p:spPr>
                      <a:xfrm>
                        <a:off x="2773697" y="1711600"/>
                        <a:ext cx="82296" cy="0"/>
                      </a:xfrm>
                      <a:prstGeom prst="line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" name="Straight Connector 39"/>
                      <p:cNvCxnSpPr/>
                      <p:nvPr/>
                    </p:nvCxnSpPr>
                    <p:spPr>
                      <a:xfrm>
                        <a:off x="1756727" y="2661256"/>
                        <a:ext cx="82296" cy="0"/>
                      </a:xfrm>
                      <a:prstGeom prst="line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1" name="Straight Connector 40"/>
                      <p:cNvCxnSpPr/>
                      <p:nvPr/>
                    </p:nvCxnSpPr>
                    <p:spPr>
                      <a:xfrm>
                        <a:off x="1756727" y="1711600"/>
                        <a:ext cx="82296" cy="0"/>
                      </a:xfrm>
                      <a:prstGeom prst="line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" name="Straight Connector 50"/>
                      <p:cNvCxnSpPr/>
                      <p:nvPr/>
                    </p:nvCxnSpPr>
                    <p:spPr>
                      <a:xfrm>
                        <a:off x="3864560" y="2648429"/>
                        <a:ext cx="82296" cy="0"/>
                      </a:xfrm>
                      <a:prstGeom prst="line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  <p:style>
                      <a:lnRef idx="3">
                        <a:schemeClr val="accent4"/>
                      </a:lnRef>
                      <a:fillRef idx="0">
                        <a:schemeClr val="accent4"/>
                      </a:fillRef>
                      <a:effectRef idx="2">
                        <a:schemeClr val="accent4"/>
                      </a:effectRef>
                      <a:fontRef idx="minor">
                        <a:schemeClr val="tx1"/>
                      </a:fontRef>
                    </p:style>
                  </p:cxnSp>
                </p:grpSp>
                <p:pic>
                  <p:nvPicPr>
                    <p:cNvPr id="32" name="Picture 31"/>
                    <p:cNvPicPr>
                      <a:picLocks noChangeAspect="1"/>
                    </p:cNvPicPr>
                    <p:nvPr/>
                  </p:nvPicPr>
                  <p:blipFill rotWithShape="1">
                    <a:blip r:embed="rId15">
                      <a:extLst>
                        <a:ext uri="{BEBA8EAE-BF5A-486C-A8C5-ECC9F3942E4B}">
                          <a14:imgProps xmlns:a14="http://schemas.microsoft.com/office/drawing/2010/main">
                            <a14:imgLayer r:embed="rId16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7020" t="27499" r="37742" b="53919"/>
                    <a:stretch/>
                  </p:blipFill>
                  <p:spPr>
                    <a:xfrm>
                      <a:off x="4742311" y="1308298"/>
                      <a:ext cx="1010023" cy="920377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3" name="Picture 52"/>
                    <p:cNvPicPr>
                      <a:picLocks noChangeAspect="1"/>
                    </p:cNvPicPr>
                    <p:nvPr/>
                  </p:nvPicPr>
                  <p:blipFill rotWithShape="1">
                    <a:blip r:embed="rId23">
                      <a:extLst>
                        <a:ext uri="{BEBA8EAE-BF5A-486C-A8C5-ECC9F3942E4B}">
                          <a14:imgProps xmlns:a14="http://schemas.microsoft.com/office/drawing/2010/main">
                            <a14:imgLayer r:embed="rId24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1556" t="76940" r="33299" b="4599"/>
                    <a:stretch/>
                  </p:blipFill>
                  <p:spPr>
                    <a:xfrm>
                      <a:off x="4748286" y="2269251"/>
                      <a:ext cx="1004048" cy="914400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4885589" y="1056566"/>
                    <a:ext cx="1527048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SET</a:t>
                    </a:r>
                    <a:endPara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7" name="Rectangle 56"/>
                <p:cNvSpPr/>
                <p:nvPr/>
              </p:nvSpPr>
              <p:spPr>
                <a:xfrm>
                  <a:off x="4249272" y="1559859"/>
                  <a:ext cx="237790" cy="235128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63" name="Straight Connector 62"/>
              <p:cNvCxnSpPr/>
              <p:nvPr/>
            </p:nvCxnSpPr>
            <p:spPr>
              <a:xfrm>
                <a:off x="5369246" y="2149238"/>
                <a:ext cx="32918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>
                <a:off x="5369246" y="3086067"/>
                <a:ext cx="32918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</p:grpSp>
        <p:sp>
          <p:nvSpPr>
            <p:cNvPr id="67" name="Rectangle 66"/>
            <p:cNvSpPr/>
            <p:nvPr/>
          </p:nvSpPr>
          <p:spPr>
            <a:xfrm>
              <a:off x="3863699" y="2826807"/>
              <a:ext cx="237790" cy="235128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9" name="Straight Connector 68"/>
            <p:cNvCxnSpPr/>
            <p:nvPr/>
          </p:nvCxnSpPr>
          <p:spPr>
            <a:xfrm flipV="1">
              <a:off x="4249272" y="1318176"/>
              <a:ext cx="484969" cy="241683"/>
            </a:xfrm>
            <a:prstGeom prst="line">
              <a:avLst/>
            </a:prstGeom>
            <a:ln w="1270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4247138" y="1788144"/>
              <a:ext cx="512882" cy="427357"/>
            </a:xfrm>
            <a:prstGeom prst="line">
              <a:avLst/>
            </a:prstGeom>
            <a:ln w="1270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V="1">
              <a:off x="3863763" y="2278982"/>
              <a:ext cx="890932" cy="533905"/>
            </a:xfrm>
            <a:prstGeom prst="line">
              <a:avLst/>
            </a:prstGeom>
            <a:ln w="1270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3855285" y="3061935"/>
              <a:ext cx="920104" cy="135636"/>
            </a:xfrm>
            <a:prstGeom prst="line">
              <a:avLst/>
            </a:prstGeom>
            <a:ln w="1270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608304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119626" y="1023043"/>
            <a:ext cx="3103726" cy="4807856"/>
            <a:chOff x="579061" y="1062800"/>
            <a:chExt cx="3103726" cy="4807856"/>
          </a:xfrm>
        </p:grpSpPr>
        <p:grpSp>
          <p:nvGrpSpPr>
            <p:cNvPr id="3" name="Group 2"/>
            <p:cNvGrpSpPr/>
            <p:nvPr/>
          </p:nvGrpSpPr>
          <p:grpSpPr>
            <a:xfrm>
              <a:off x="579061" y="2624081"/>
              <a:ext cx="3103726" cy="3246575"/>
              <a:chOff x="108462" y="3623843"/>
              <a:chExt cx="3103726" cy="3246575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108462" y="3623843"/>
                <a:ext cx="3103726" cy="3246575"/>
                <a:chOff x="108462" y="3623843"/>
                <a:chExt cx="3103726" cy="3246575"/>
              </a:xfrm>
            </p:grpSpPr>
            <p:sp>
              <p:nvSpPr>
                <p:cNvPr id="13" name="Oval 12"/>
                <p:cNvSpPr/>
                <p:nvPr/>
              </p:nvSpPr>
              <p:spPr>
                <a:xfrm>
                  <a:off x="1528799" y="3694004"/>
                  <a:ext cx="139296" cy="120165"/>
                </a:xfrm>
                <a:prstGeom prst="ellipse">
                  <a:avLst/>
                </a:prstGeom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14" name="Group 13"/>
                <p:cNvGrpSpPr/>
                <p:nvPr/>
              </p:nvGrpSpPr>
              <p:grpSpPr>
                <a:xfrm>
                  <a:off x="108462" y="3623843"/>
                  <a:ext cx="3103726" cy="3246575"/>
                  <a:chOff x="247758" y="3623843"/>
                  <a:chExt cx="3103726" cy="3246575"/>
                </a:xfrm>
              </p:grpSpPr>
              <p:grpSp>
                <p:nvGrpSpPr>
                  <p:cNvPr id="15" name="Group 14"/>
                  <p:cNvGrpSpPr/>
                  <p:nvPr/>
                </p:nvGrpSpPr>
                <p:grpSpPr>
                  <a:xfrm>
                    <a:off x="247758" y="6276769"/>
                    <a:ext cx="3103726" cy="593649"/>
                    <a:chOff x="361099" y="6213343"/>
                    <a:chExt cx="3103726" cy="593649"/>
                  </a:xfrm>
                </p:grpSpPr>
                <p:sp>
                  <p:nvSpPr>
                    <p:cNvPr id="29" name="Oval 28"/>
                    <p:cNvSpPr/>
                    <p:nvPr/>
                  </p:nvSpPr>
                  <p:spPr>
                    <a:xfrm>
                      <a:off x="1815803" y="6213343"/>
                      <a:ext cx="915806" cy="466722"/>
                    </a:xfrm>
                    <a:prstGeom prst="ellipse">
                      <a:avLst/>
                    </a:prstGeom>
                  </p:spPr>
                  <p:style>
                    <a:lnRef idx="0">
                      <a:schemeClr val="accent2"/>
                    </a:lnRef>
                    <a:fillRef idx="3">
                      <a:schemeClr val="accent2"/>
                    </a:fillRef>
                    <a:effectRef idx="3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0" name="Oval 29"/>
                    <p:cNvSpPr/>
                    <p:nvPr/>
                  </p:nvSpPr>
                  <p:spPr>
                    <a:xfrm>
                      <a:off x="443514" y="6253392"/>
                      <a:ext cx="780894" cy="553600"/>
                    </a:xfrm>
                    <a:prstGeom prst="ellipse">
                      <a:avLst/>
                    </a:prstGeom>
                  </p:spPr>
                  <p:style>
                    <a:lnRef idx="0">
                      <a:schemeClr val="accent5"/>
                    </a:lnRef>
                    <a:fillRef idx="3">
                      <a:schemeClr val="accent5"/>
                    </a:fillRef>
                    <a:effectRef idx="3">
                      <a:schemeClr val="accent5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1" name="TextBox 30"/>
                    <p:cNvSpPr txBox="1"/>
                    <p:nvPr/>
                  </p:nvSpPr>
                  <p:spPr>
                    <a:xfrm>
                      <a:off x="361099" y="6341212"/>
                      <a:ext cx="147129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catenin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2" name="TextBox 31"/>
                    <p:cNvSpPr txBox="1"/>
                    <p:nvPr/>
                  </p:nvSpPr>
                  <p:spPr>
                    <a:xfrm>
                      <a:off x="1993531" y="6319806"/>
                      <a:ext cx="147129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AIL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6" name="Group 15"/>
                  <p:cNvGrpSpPr/>
                  <p:nvPr/>
                </p:nvGrpSpPr>
                <p:grpSpPr>
                  <a:xfrm rot="8351733">
                    <a:off x="522500" y="5398422"/>
                    <a:ext cx="1165587" cy="763626"/>
                    <a:chOff x="4896582" y="3420221"/>
                    <a:chExt cx="1165587" cy="763626"/>
                  </a:xfrm>
                </p:grpSpPr>
                <p:cxnSp>
                  <p:nvCxnSpPr>
                    <p:cNvPr id="27" name="Straight Connector 26"/>
                    <p:cNvCxnSpPr/>
                    <p:nvPr/>
                  </p:nvCxnSpPr>
                  <p:spPr>
                    <a:xfrm flipV="1">
                      <a:off x="4896582" y="3558914"/>
                      <a:ext cx="1122393" cy="624933"/>
                    </a:xfrm>
                    <a:prstGeom prst="line">
                      <a:avLst/>
                    </a:prstGeom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Straight Connector 27"/>
                    <p:cNvCxnSpPr/>
                    <p:nvPr/>
                  </p:nvCxnSpPr>
                  <p:spPr>
                    <a:xfrm>
                      <a:off x="5943534" y="3420221"/>
                      <a:ext cx="118635" cy="242998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1658326" y="5013659"/>
                    <a:ext cx="147129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r</a:t>
                    </a:r>
                    <a:r>
                      <a:rPr 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9</a:t>
                    </a:r>
                    <a:endParaRPr lang="en-US" sz="1000" b="1" dirty="0">
                      <a:latin typeface="Symbol" panose="05050102010706020507" pitchFamily="18" charset="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1765446" y="3636138"/>
                    <a:ext cx="147129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r</a:t>
                    </a:r>
                    <a:r>
                      <a:rPr 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73</a:t>
                    </a:r>
                    <a:endParaRPr lang="en-US" sz="1000" b="1" dirty="0">
                      <a:latin typeface="Symbol" panose="05050102010706020507" pitchFamily="18" charset="2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9" name="Group 18"/>
                  <p:cNvGrpSpPr/>
                  <p:nvPr/>
                </p:nvGrpSpPr>
                <p:grpSpPr>
                  <a:xfrm rot="3307108">
                    <a:off x="1078773" y="5678218"/>
                    <a:ext cx="1030875" cy="301990"/>
                    <a:chOff x="1348106" y="5470797"/>
                    <a:chExt cx="1030875" cy="301990"/>
                  </a:xfrm>
                </p:grpSpPr>
                <p:cxnSp>
                  <p:nvCxnSpPr>
                    <p:cNvPr id="25" name="Straight Connector 24"/>
                    <p:cNvCxnSpPr/>
                    <p:nvPr/>
                  </p:nvCxnSpPr>
                  <p:spPr>
                    <a:xfrm flipV="1">
                      <a:off x="1348106" y="5606351"/>
                      <a:ext cx="1030407" cy="15761"/>
                    </a:xfrm>
                    <a:prstGeom prst="line">
                      <a:avLst/>
                    </a:prstGeom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" name="Straight Connector 25"/>
                    <p:cNvCxnSpPr/>
                    <p:nvPr/>
                  </p:nvCxnSpPr>
                  <p:spPr>
                    <a:xfrm>
                      <a:off x="2370399" y="5470797"/>
                      <a:ext cx="8582" cy="30199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0" name="Group 19"/>
                  <p:cNvGrpSpPr/>
                  <p:nvPr/>
                </p:nvGrpSpPr>
                <p:grpSpPr>
                  <a:xfrm rot="7187856">
                    <a:off x="745606" y="3967262"/>
                    <a:ext cx="1122393" cy="807314"/>
                    <a:chOff x="4926593" y="3335570"/>
                    <a:chExt cx="1122393" cy="807314"/>
                  </a:xfrm>
                </p:grpSpPr>
                <p:cxnSp>
                  <p:nvCxnSpPr>
                    <p:cNvPr id="23" name="Straight Connector 22"/>
                    <p:cNvCxnSpPr/>
                    <p:nvPr/>
                  </p:nvCxnSpPr>
                  <p:spPr>
                    <a:xfrm flipV="1">
                      <a:off x="4926593" y="3517951"/>
                      <a:ext cx="1122393" cy="624933"/>
                    </a:xfrm>
                    <a:prstGeom prst="line">
                      <a:avLst/>
                    </a:prstGeom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" name="Straight Connector 23"/>
                    <p:cNvCxnSpPr/>
                    <p:nvPr/>
                  </p:nvCxnSpPr>
                  <p:spPr>
                    <a:xfrm rot="14412144" flipH="1" flipV="1">
                      <a:off x="5854211" y="3512373"/>
                      <a:ext cx="361621" cy="8016"/>
                    </a:xfrm>
                    <a:prstGeom prst="line">
                      <a:avLst/>
                    </a:prstGeom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1" name="Oval 20"/>
                  <p:cNvSpPr/>
                  <p:nvPr/>
                </p:nvSpPr>
                <p:spPr>
                  <a:xfrm>
                    <a:off x="790317" y="3623843"/>
                    <a:ext cx="915806" cy="466722"/>
                  </a:xfrm>
                  <a:prstGeom prst="ellipse">
                    <a:avLst/>
                  </a:prstGeom>
                </p:spPr>
                <p:style>
                  <a:lnRef idx="1">
                    <a:schemeClr val="accent3"/>
                  </a:lnRef>
                  <a:fillRef idx="2">
                    <a:schemeClr val="accent3"/>
                  </a:fillRef>
                  <a:effectRef idx="1">
                    <a:schemeClr val="accent3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2" name="TextBox 21"/>
                  <p:cNvSpPr txBox="1"/>
                  <p:nvPr/>
                </p:nvSpPr>
                <p:spPr>
                  <a:xfrm>
                    <a:off x="1003548" y="3715285"/>
                    <a:ext cx="52512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KT</a:t>
                    </a:r>
                    <a:endParaRPr lang="en-US" sz="1200" b="1" dirty="0">
                      <a:latin typeface="Symbol" panose="05050102010706020507" pitchFamily="18" charset="2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0" name="Oval 9"/>
              <p:cNvSpPr/>
              <p:nvPr/>
            </p:nvSpPr>
            <p:spPr>
              <a:xfrm>
                <a:off x="672852" y="4987569"/>
                <a:ext cx="835553" cy="385816"/>
              </a:xfrm>
              <a:prstGeom prst="ellipse">
                <a:avLst/>
              </a:prstGeom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759921" y="5026316"/>
                <a:ext cx="14712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SK3</a:t>
                </a:r>
                <a:r>
                  <a:rPr lang="en-US" sz="1200" b="1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endParaRPr lang="en-US" sz="1200" b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  <p:sp>
            <p:nvSpPr>
              <p:cNvPr id="12" name="Oval 11"/>
              <p:cNvSpPr/>
              <p:nvPr/>
            </p:nvSpPr>
            <p:spPr>
              <a:xfrm>
                <a:off x="1438479" y="5091056"/>
                <a:ext cx="139296" cy="120165"/>
              </a:xfrm>
              <a:prstGeom prst="ellipse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" name="Oval 3"/>
            <p:cNvSpPr/>
            <p:nvPr/>
          </p:nvSpPr>
          <p:spPr>
            <a:xfrm>
              <a:off x="1121620" y="1114581"/>
              <a:ext cx="915806" cy="466722"/>
            </a:xfrm>
            <a:prstGeom prst="ellipse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316960" y="1228777"/>
              <a:ext cx="5921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3-K</a:t>
              </a:r>
              <a:endParaRPr lang="en-US" sz="12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6" name="Oval 5"/>
            <p:cNvSpPr/>
            <p:nvPr/>
          </p:nvSpPr>
          <p:spPr>
            <a:xfrm>
              <a:off x="1957376" y="1120666"/>
              <a:ext cx="139296" cy="120165"/>
            </a:xfrm>
            <a:prstGeom prst="ellipse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054727" y="1062800"/>
              <a:ext cx="14712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yr458</a:t>
              </a:r>
              <a:endParaRPr lang="en-US" sz="10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cxnSp>
          <p:nvCxnSpPr>
            <p:cNvPr id="8" name="Straight Arrow Connector 7"/>
            <p:cNvCxnSpPr>
              <a:stCxn id="4" idx="4"/>
              <a:endCxn id="21" idx="0"/>
            </p:cNvCxnSpPr>
            <p:nvPr/>
          </p:nvCxnSpPr>
          <p:spPr>
            <a:xfrm>
              <a:off x="1579523" y="1581303"/>
              <a:ext cx="0" cy="104277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 Box 94"/>
          <p:cNvSpPr txBox="1">
            <a:spLocks noChangeArrowheads="1"/>
          </p:cNvSpPr>
          <p:nvPr/>
        </p:nvSpPr>
        <p:spPr bwMode="auto">
          <a:xfrm>
            <a:off x="4712383" y="27851"/>
            <a:ext cx="27018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5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567589" y="1355206"/>
            <a:ext cx="14712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yr199</a:t>
            </a:r>
            <a:endParaRPr lang="en-US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35" name="Oval 34"/>
          <p:cNvSpPr/>
          <p:nvPr/>
        </p:nvSpPr>
        <p:spPr>
          <a:xfrm>
            <a:off x="3469863" y="1401754"/>
            <a:ext cx="139296" cy="120165"/>
          </a:xfrm>
          <a:prstGeom prst="ellips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986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32</TotalTime>
  <Words>251</Words>
  <Application>Microsoft Office PowerPoint</Application>
  <PresentationFormat>A4 Paper (210x297 mm)</PresentationFormat>
  <Paragraphs>153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ＭＳ Ｐゴシック</vt:lpstr>
      <vt:lpstr>Arial</vt:lpstr>
      <vt:lpstr>Calibri</vt:lpstr>
      <vt:lpstr>Calibri Light</vt:lpstr>
      <vt:lpstr>Symbol</vt:lpstr>
      <vt:lpstr>Times New Roman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xena, Sugandha</dc:creator>
  <cp:lastModifiedBy>Saxena, Sugandha</cp:lastModifiedBy>
  <cp:revision>90</cp:revision>
  <cp:lastPrinted>2018-11-09T15:26:51Z</cp:lastPrinted>
  <dcterms:created xsi:type="dcterms:W3CDTF">2017-08-28T00:17:00Z</dcterms:created>
  <dcterms:modified xsi:type="dcterms:W3CDTF">2018-11-09T15:26:53Z</dcterms:modified>
</cp:coreProperties>
</file>